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C4F5F7FE-F58C-4968-A037-34D1FA199ECE}"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509BC04-CA9F-465A-9A79-2920EFA1BCD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3D18B50-18BD-46E2-BBB6-FEDAE6D38BB6}"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A9F099EC-A87C-48D6-9EB6-9AF3B5CB2D74}"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32C62E2-C8BA-4B7B-A353-C047F6DCABF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C166C61-0D9A-40A4-8521-0A31FBDC985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2F9B556-78DA-4971-A5FE-F17D9A1A6F0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5922B16-CD82-4441-A55D-461FA20564C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0C92D69-6E91-464F-B626-81E83D2A97C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322602B-9EA3-40A5-AB5E-CFB21A243B8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6466496-5260-4808-B6AD-72C534AFF9E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22E11FD-2DE1-4F03-B2EE-E63721628051}"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A7C1B3D-007D-4C11-8406-2E2B99D8E453}"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3.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1" name="" descr=""/>
          <p:cNvPicPr/>
          <p:nvPr/>
        </p:nvPicPr>
        <p:blipFill>
          <a:blip r:embed="rId1"/>
          <a:stretch/>
        </p:blipFill>
        <p:spPr>
          <a:xfrm>
            <a:off x="152280" y="0"/>
            <a:ext cx="4502160" cy="6629400"/>
          </a:xfrm>
          <a:prstGeom prst="rect">
            <a:avLst/>
          </a:prstGeom>
          <a:ln w="0">
            <a:noFill/>
          </a:ln>
        </p:spPr>
      </p:pic>
      <p:sp>
        <p:nvSpPr>
          <p:cNvPr id="42" name=""/>
          <p:cNvSpPr/>
          <p:nvPr/>
        </p:nvSpPr>
        <p:spPr>
          <a:xfrm>
            <a:off x="4267080" y="4345920"/>
            <a:ext cx="4496040" cy="213228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ea typeface="Times New Roman"/>
              </a:rPr>
              <a:t>Supplementary Figure 2 </a:t>
            </a:r>
            <a:r>
              <a:rPr b="0" lang="en-US" sz="1400" spc="-1" strike="noStrike">
                <a:solidFill>
                  <a:srgbClr val="000000"/>
                </a:solidFill>
                <a:latin typeface="Times New Roman"/>
                <a:ea typeface="Times New Roman"/>
              </a:rPr>
              <a:t>Secondary transplanted</a:t>
            </a:r>
            <a:r>
              <a:rPr b="0" lang="en-US" sz="1200" spc="-1" strike="noStrike">
                <a:solidFill>
                  <a:srgbClr val="000000"/>
                </a:solidFill>
                <a:latin typeface="Arial"/>
              </a:rPr>
              <a:t> brain tumors from PASC1 express human GH. Immuno-fluorescence staining of brain sections from mice implanted with PASC1-initiated brain tumor cells for 12 weeks using antibodies against human specific nuclei and human GH.  Three different tumor samples were shown with similar results.  Human specific antibody stained cells were visualized by FITC-conjugated secondary antibody (green). The human GH positive cells were identified by Texas-Red-conjugated secondary antibody (red). DAPI was used for identifying nuclei (blue). Note the similarities in staining to the primary xenografts Figure 5A).</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06-04T16:06:53Z</dcterms:created>
  <dc:creator>CSHS</dc:creator>
  <dc:description/>
  <dc:language>en-US</dc:language>
  <cp:lastModifiedBy>CSHS</cp:lastModifiedBy>
  <dcterms:modified xsi:type="dcterms:W3CDTF">2009-06-04T16:06:59Z</dcterms:modified>
  <cp:revision>1</cp:revision>
  <dc:subject/>
  <dc:title>Slide 1</dc:title>
</cp:coreProperties>
</file>